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9" r:id="rId3"/>
    <p:sldId id="258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901" autoAdjust="0"/>
    <p:restoredTop sz="94660"/>
  </p:normalViewPr>
  <p:slideViewPr>
    <p:cSldViewPr snapToGrid="0">
      <p:cViewPr varScale="1">
        <p:scale>
          <a:sx n="80" d="100"/>
          <a:sy n="80" d="100"/>
        </p:scale>
        <p:origin x="32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067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519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468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191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413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919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123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782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437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810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149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111E2B-2F2F-4E8A-9B73-6AC8EB60186E}" type="datetimeFigureOut">
              <a:rPr lang="en-US" smtClean="0"/>
              <a:t>6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1FC53-B690-4423-991F-50BB25F9B2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89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E50B738-98DF-41BF-B746-87B876F84783}"/>
              </a:ext>
            </a:extLst>
          </p:cNvPr>
          <p:cNvSpPr txBox="1"/>
          <p:nvPr/>
        </p:nvSpPr>
        <p:spPr>
          <a:xfrm>
            <a:off x="55794" y="443613"/>
            <a:ext cx="8825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BBF65E9-81D6-4212-9EBF-2C81BBE0BF2C}"/>
              </a:ext>
            </a:extLst>
          </p:cNvPr>
          <p:cNvSpPr txBox="1"/>
          <p:nvPr/>
        </p:nvSpPr>
        <p:spPr>
          <a:xfrm>
            <a:off x="55795" y="0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716AF58-716E-44F9-A377-737735F0E1F8}"/>
              </a:ext>
            </a:extLst>
          </p:cNvPr>
          <p:cNvGrpSpPr/>
          <p:nvPr/>
        </p:nvGrpSpPr>
        <p:grpSpPr>
          <a:xfrm>
            <a:off x="378068" y="872104"/>
            <a:ext cx="2860579" cy="1758709"/>
            <a:chOff x="3118640" y="709310"/>
            <a:chExt cx="2860578" cy="1758708"/>
          </a:xfrm>
        </p:grpSpPr>
        <p:pic>
          <p:nvPicPr>
            <p:cNvPr id="7" name="Picture 6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7EECCD2A-C253-4A88-866A-38E6AE328E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5653" y="959576"/>
              <a:ext cx="1293290" cy="1216914"/>
            </a:xfrm>
            <a:prstGeom prst="rect">
              <a:avLst/>
            </a:prstGeom>
          </p:spPr>
        </p:pic>
        <p:pic>
          <p:nvPicPr>
            <p:cNvPr id="9" name="Picture 8" descr="Chart, scatter chart&#10;&#10;Description automatically generated">
              <a:extLst>
                <a:ext uri="{FF2B5EF4-FFF2-40B4-BE49-F238E27FC236}">
                  <a16:creationId xmlns:a16="http://schemas.microsoft.com/office/drawing/2014/main" id="{4EDD4511-92B5-4498-91EB-C199735D13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85928" y="975977"/>
              <a:ext cx="1293290" cy="1216914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C5B5A75-8B01-46F1-99D8-DF0977DA6DA4}"/>
                </a:ext>
              </a:extLst>
            </p:cNvPr>
            <p:cNvSpPr txBox="1"/>
            <p:nvPr/>
          </p:nvSpPr>
          <p:spPr>
            <a:xfrm rot="16200000">
              <a:off x="2927429" y="1541843"/>
              <a:ext cx="6286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38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3961A17-3ABC-4540-A5BE-94B096DF7FAF}"/>
                </a:ext>
              </a:extLst>
            </p:cNvPr>
            <p:cNvSpPr txBox="1"/>
            <p:nvPr/>
          </p:nvSpPr>
          <p:spPr>
            <a:xfrm>
              <a:off x="3599312" y="2221797"/>
              <a:ext cx="6204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MC7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227E130-A44E-4E8A-879C-86973581AFF4}"/>
                </a:ext>
              </a:extLst>
            </p:cNvPr>
            <p:cNvSpPr txBox="1"/>
            <p:nvPr/>
          </p:nvSpPr>
          <p:spPr>
            <a:xfrm>
              <a:off x="4952540" y="709310"/>
              <a:ext cx="75256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rbo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24A5DAFA-2127-426A-8277-BB6F9AB3CED2}"/>
                </a:ext>
              </a:extLst>
            </p:cNvPr>
            <p:cNvCxnSpPr>
              <a:cxnSpLocks/>
            </p:cNvCxnSpPr>
            <p:nvPr/>
          </p:nvCxnSpPr>
          <p:spPr>
            <a:xfrm>
              <a:off x="3568700" y="2221794"/>
              <a:ext cx="61986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46795754-40A6-4A67-8CE2-23CD89ABB27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70220" y="1470337"/>
              <a:ext cx="0" cy="55137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D4261B9-DF78-4CDC-908B-D593278278A9}"/>
                </a:ext>
              </a:extLst>
            </p:cNvPr>
            <p:cNvSpPr txBox="1"/>
            <p:nvPr/>
          </p:nvSpPr>
          <p:spPr>
            <a:xfrm>
              <a:off x="3493303" y="709310"/>
              <a:ext cx="115975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Original tumo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573841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E50B738-98DF-41BF-B746-87B876F84783}"/>
              </a:ext>
            </a:extLst>
          </p:cNvPr>
          <p:cNvSpPr txBox="1"/>
          <p:nvPr/>
        </p:nvSpPr>
        <p:spPr>
          <a:xfrm>
            <a:off x="18216" y="443613"/>
            <a:ext cx="8825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BBF65E9-81D6-4212-9EBF-2C81BBE0BF2C}"/>
              </a:ext>
            </a:extLst>
          </p:cNvPr>
          <p:cNvSpPr txBox="1"/>
          <p:nvPr/>
        </p:nvSpPr>
        <p:spPr>
          <a:xfrm>
            <a:off x="18217" y="0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9DCF46BC-217F-4236-9D46-8091381E16F6}"/>
              </a:ext>
            </a:extLst>
          </p:cNvPr>
          <p:cNvGrpSpPr/>
          <p:nvPr/>
        </p:nvGrpSpPr>
        <p:grpSpPr>
          <a:xfrm>
            <a:off x="204022" y="909823"/>
            <a:ext cx="3519237" cy="3519237"/>
            <a:chOff x="101521" y="517612"/>
            <a:chExt cx="3519237" cy="3519237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BB01A43C-7F8D-4EB8-9CD8-30B44B147F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521" y="517612"/>
              <a:ext cx="3519237" cy="3519237"/>
            </a:xfrm>
            <a:prstGeom prst="rect">
              <a:avLst/>
            </a:prstGeom>
          </p:spPr>
        </p:pic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72C86010-1D8A-47E1-9B18-BDDFB38E0F8E}"/>
                </a:ext>
              </a:extLst>
            </p:cNvPr>
            <p:cNvSpPr/>
            <p:nvPr/>
          </p:nvSpPr>
          <p:spPr>
            <a:xfrm>
              <a:off x="1601897" y="2018182"/>
              <a:ext cx="107707" cy="107707"/>
            </a:xfrm>
            <a:prstGeom prst="ellipse">
              <a:avLst/>
            </a:prstGeom>
            <a:solidFill>
              <a:srgbClr val="0297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552FB76F-158E-43DB-92D6-CB7D04289FCB}"/>
                </a:ext>
              </a:extLst>
            </p:cNvPr>
            <p:cNvSpPr/>
            <p:nvPr/>
          </p:nvSpPr>
          <p:spPr>
            <a:xfrm>
              <a:off x="1601897" y="2164577"/>
              <a:ext cx="107707" cy="107707"/>
            </a:xfrm>
            <a:prstGeom prst="ellipse">
              <a:avLst/>
            </a:prstGeom>
            <a:solidFill>
              <a:srgbClr val="00915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0F91348-E694-4270-9A57-580788B55905}"/>
                </a:ext>
              </a:extLst>
            </p:cNvPr>
            <p:cNvSpPr txBox="1"/>
            <p:nvPr/>
          </p:nvSpPr>
          <p:spPr>
            <a:xfrm>
              <a:off x="1688105" y="1976835"/>
              <a:ext cx="5246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rbo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C6E08DD-2C2F-46EC-B572-021D24AECC9B}"/>
                </a:ext>
              </a:extLst>
            </p:cNvPr>
            <p:cNvSpPr txBox="1"/>
            <p:nvPr/>
          </p:nvSpPr>
          <p:spPr>
            <a:xfrm>
              <a:off x="1688105" y="2120033"/>
              <a:ext cx="8900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riginal tumo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952866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8A6D1DC2-ACD2-4A5C-9709-78E44AD49B58}"/>
              </a:ext>
            </a:extLst>
          </p:cNvPr>
          <p:cNvSpPr txBox="1"/>
          <p:nvPr/>
        </p:nvSpPr>
        <p:spPr>
          <a:xfrm>
            <a:off x="80175" y="3"/>
            <a:ext cx="26468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1574318-184B-2442-AE09-8B1F7B7DC555}"/>
              </a:ext>
            </a:extLst>
          </p:cNvPr>
          <p:cNvSpPr txBox="1"/>
          <p:nvPr/>
        </p:nvSpPr>
        <p:spPr>
          <a:xfrm>
            <a:off x="80176" y="443613"/>
            <a:ext cx="8825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Shape&#10;&#10;Description automatically generated with low confidence">
            <a:extLst>
              <a:ext uri="{FF2B5EF4-FFF2-40B4-BE49-F238E27FC236}">
                <a16:creationId xmlns:a16="http://schemas.microsoft.com/office/drawing/2014/main" id="{2C449B2C-0678-4A34-AE6A-2DE9C2C7EE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75" y="947626"/>
            <a:ext cx="3082356" cy="21869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65999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291971-DC18-BCD3-007E-FA5E1E40AE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41B602-E88C-04B1-3407-E44E18D9D6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s: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low cytometry for FMC7 and CD38 comparing primary MCL cells and Arbo.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MC7 that was positive in Arbo (100%) and negative in primary cells (6%), while CD38 that was negative in Arbo (0%) and positive in the primary cells (97%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: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ole exome sequencing (WES) comparing DNA collected from Arbo and primary MCL cells of the tumor.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hromosomes 1 to 26 X and Y are represented on the outer circle, SNPs with a depth of more than 100 are represented on the inner circles for Arbo (blue circle) and primary tumor (green circle) with each dot representing an SNP, higher peaks indicate a higher depth of the SNP. Key detected mutations were present in the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M, TP53,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TCH2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s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: </a:t>
            </a:r>
            <a:r>
              <a:rPr lang="en-US" sz="1800" b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se dependent changes in Arbo’s viability following a 48h exposure to venetoclax or ibrutinib.</a:t>
            </a:r>
            <a:endParaRPr lang="en-US" sz="18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420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33</TotalTime>
  <Words>193</Words>
  <Application>Microsoft Office PowerPoint</Application>
  <PresentationFormat>A4 Paper (210x297 mm)</PresentationFormat>
  <Paragraphs>1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ras Safa</dc:creator>
  <cp:lastModifiedBy>Firas Safa</cp:lastModifiedBy>
  <cp:revision>23</cp:revision>
  <dcterms:created xsi:type="dcterms:W3CDTF">2021-08-16T11:52:37Z</dcterms:created>
  <dcterms:modified xsi:type="dcterms:W3CDTF">2022-06-06T11:44:54Z</dcterms:modified>
</cp:coreProperties>
</file>